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EA22D3-2BDF-426A-902E-63ED142B0FD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4FA0FF-2150-4E6F-841B-41A401B8384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B2DDFC-8CCC-4672-9672-E8D8C18D19B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67D811-21E2-413D-AD30-B748BF8FAD3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66B3E2-0AFB-4971-8E1E-6AD4BEF3C48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A63C45-C3DF-41A3-B00E-5E10C454B80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ACCEAE-4E20-4E75-A278-D63BBEA40B6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1E39E0-354D-4AFC-8955-5C798618BCD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6BE857-7995-48DD-9082-94CEF263CE7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CECD2A-8542-43AB-AA80-834F7F4F293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43BCB1-996A-4AF4-AD51-20204E7A6FA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90C52A-A603-48FE-9C9F-55FEFA58986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D07DACE-D542-42FE-868D-EF71529E9889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228600" y="990720"/>
          <a:ext cx="6553080" cy="3405240"/>
        </p:xfrm>
        <a:graphic>
          <a:graphicData uri="http://schemas.openxmlformats.org/drawingml/2006/table">
            <a:tbl>
              <a:tblPr/>
              <a:tblGrid>
                <a:gridCol w="860400"/>
                <a:gridCol w="574560"/>
                <a:gridCol w="774720"/>
                <a:gridCol w="838440"/>
                <a:gridCol w="1218960"/>
                <a:gridCol w="914400"/>
                <a:gridCol w="1371600"/>
              </a:tblGrid>
              <a:tr h="22680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Tumor I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2b2b2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Stag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2b2b2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Age at D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2b2b2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Statu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2b2b2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Survival (Months)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2b2b2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Recurrenc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2b2b2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Platinum Sensitiv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2b2b2"/>
                    </a:solidFill>
                  </a:tcPr>
                </a:tc>
              </a:tr>
              <a:tr h="22716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SOC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III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73.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Aliv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5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680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SOC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III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84.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Aliv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5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716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SOC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III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70.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Decease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716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SOC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III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90.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Decease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680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SOC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IV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76.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Decease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716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SOC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IV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61.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Decease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.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680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SOC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III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65.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Aliv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716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SOC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/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73.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Decease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716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SOC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IV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67.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Decease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680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SOC1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III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74.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Decease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716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SOC1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/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71.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Aliv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5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680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SOC1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III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64.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Aliv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3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716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SOC1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IV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56.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Decease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3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716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SOC1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IV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38.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Aliv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1-12T14:46:28Z</dcterms:created>
  <dc:creator>Partners Information Systems</dc:creator>
  <dc:description/>
  <dc:language>en-US</dc:language>
  <cp:lastModifiedBy>Partners Information Systems</cp:lastModifiedBy>
  <dcterms:modified xsi:type="dcterms:W3CDTF">2011-10-12T13:26:33Z</dcterms:modified>
  <cp:revision>11</cp:revision>
  <dc:subject/>
  <dc:title>Slide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NewReviewCycle">
    <vt:lpwstr/>
  </property>
</Properties>
</file>